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592" y="-10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395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64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4582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4938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865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94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2525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890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8491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631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078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D925DD-EDEC-439A-B088-2497D4541496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AE598-8EB8-4263-BEF0-FA94C33339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450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グラフィックス 4">
            <a:extLst>
              <a:ext uri="{FF2B5EF4-FFF2-40B4-BE49-F238E27FC236}">
                <a16:creationId xmlns:a16="http://schemas.microsoft.com/office/drawing/2014/main" id="{7E13C954-3C32-6FD0-F30A-3511426F83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20796" y="1054548"/>
            <a:ext cx="6858000" cy="4857750"/>
          </a:xfrm>
          <a:prstGeom prst="rect">
            <a:avLst/>
          </a:prstGeom>
        </p:spPr>
      </p:pic>
      <p:sp>
        <p:nvSpPr>
          <p:cNvPr id="2" name="コンテンツ プレースホルダー 2">
            <a:extLst>
              <a:ext uri="{FF2B5EF4-FFF2-40B4-BE49-F238E27FC236}">
                <a16:creationId xmlns:a16="http://schemas.microsoft.com/office/drawing/2014/main" id="{173CAE45-A5D8-B7DD-DEFE-0B3C8190151D}"/>
              </a:ext>
            </a:extLst>
          </p:cNvPr>
          <p:cNvSpPr txBox="1">
            <a:spLocks/>
          </p:cNvSpPr>
          <p:nvPr/>
        </p:nvSpPr>
        <p:spPr>
          <a:xfrm>
            <a:off x="203938" y="6071336"/>
            <a:ext cx="6513919" cy="35110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kumimoji="1"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ja-JP" altLang="en-US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lti-tissue </a:t>
            </a:r>
            <a:r>
              <a:rPr lang="en-US" altLang="ja-JP" sz="1200" b="1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QTL</a:t>
            </a:r>
            <a:r>
              <a:rPr lang="en-US" altLang="ja-JP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mparison of </a:t>
            </a:r>
            <a:r>
              <a:rPr lang="en-US" altLang="ja-JP" sz="1200" b="1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2</a:t>
            </a:r>
            <a:r>
              <a:rPr lang="en-US" altLang="ja-JP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RNA expression on rs2243057 SNP genotype. 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lti-tissue </a:t>
            </a:r>
            <a:r>
              <a:rPr lang="en-US" altLang="ja-JP" sz="1200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QTLs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rs2243057, based on </a:t>
            </a:r>
            <a:r>
              <a:rPr lang="en-US" altLang="ja-JP" sz="1200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Ex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re shown</a:t>
            </a:r>
            <a:r>
              <a:rPr lang="en-US" altLang="ja-JP" sz="1200" baseline="300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normalized effect size (NES) of single-tissue </a:t>
            </a:r>
            <a:r>
              <a:rPr lang="en-US" altLang="ja-JP" sz="1200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QTLs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hows the genotypic trend of the amount of </a:t>
            </a:r>
            <a:r>
              <a:rPr lang="en-US" altLang="ja-JP" sz="1200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2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RNA expression in tissue. Negative NES values mean an mRNA expression trend of AA &lt; AG &lt; GG. </a:t>
            </a:r>
            <a:r>
              <a:rPr lang="en-US" altLang="ja-JP" sz="1200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2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RNA expression dependent on rs2243057 genotypes was AA &lt; AG &lt; GG in brain tissues, such as frontal cortex (BA9), cortex, and anterior cingulate cortex (BA24), indicating a genetic effect of rs2243057 genotypes on </a:t>
            </a:r>
            <a:r>
              <a:rPr lang="en-US" altLang="ja-JP" sz="1200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2</a:t>
            </a:r>
            <a:r>
              <a:rPr lang="en-US" altLang="ja-JP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RNA expression.</a:t>
            </a:r>
          </a:p>
        </p:txBody>
      </p:sp>
    </p:spTree>
    <p:extLst>
      <p:ext uri="{BB962C8B-B14F-4D97-AF65-F5344CB8AC3E}">
        <p14:creationId xmlns:p14="http://schemas.microsoft.com/office/powerpoint/2010/main" val="3023704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9</TotalTime>
  <Words>11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eda moe</dc:creator>
  <cp:lastModifiedBy>MDPI-023</cp:lastModifiedBy>
  <cp:revision>28</cp:revision>
  <dcterms:created xsi:type="dcterms:W3CDTF">2022-06-24T08:37:08Z</dcterms:created>
  <dcterms:modified xsi:type="dcterms:W3CDTF">2023-12-15T12:16:18Z</dcterms:modified>
</cp:coreProperties>
</file>